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6" d="100"/>
          <a:sy n="106" d="100"/>
        </p:scale>
        <p:origin x="75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80C439-CB7E-2D96-82B2-ED588B44716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D759A54-3B6A-E4D8-48DA-78EF4C23E63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965078-3F9B-A461-6682-30EFB5F320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85C8C-C0B2-4E24-8146-7579DAA60EFE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BCD456-D821-41B7-3CBE-6696A793F8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32E05F-AB35-C209-57C1-54E4E500EB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78D36-185C-4E3A-8316-15111C1282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33905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2FB0FF-92AE-8909-7DF4-1E4C62B5AA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CC06B86-10D4-B3B9-AB8A-DCE68B4664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2E2902-F2DD-6CAE-506B-5E40CF4617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85C8C-C0B2-4E24-8146-7579DAA60EFE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504B20-BD65-E568-84D5-29442E4017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40BD24-34A1-28BF-8F07-2FDFF78527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78D36-185C-4E3A-8316-15111C1282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76102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C402F54-F658-4C52-094B-D514E996E77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912304C-D580-746A-EC63-7F0DCC9298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CF9DAF-1E9C-69F1-26FB-F7FAFE91DE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85C8C-C0B2-4E24-8146-7579DAA60EFE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9022D7-E6EE-A724-681C-7E83756E3E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194995-4019-7153-1843-30BA9B90C8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78D36-185C-4E3A-8316-15111C1282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7183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CA0787-42C5-3F02-3D27-55B2476A22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2305E6-F55B-3D11-37A5-56C2FEA3679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91955A-D454-AA64-F447-05DCB8923A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85C8C-C0B2-4E24-8146-7579DAA60EFE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CA8BE7-DDA5-CE0F-3B53-67C146B514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3D6F0D-4FE8-F5F5-3789-A4D9496450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78D36-185C-4E3A-8316-15111C1282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54515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EC702A-3E8E-C373-8004-4D7438D195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0B6A28-AC16-0BE1-7867-44A7423129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715AC1-3EEF-BEA2-59D1-3D7EA0AC70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85C8C-C0B2-4E24-8146-7579DAA60EFE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D7B1A5-EDEA-EEEE-6E62-623701058C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2BC5A5-100C-31D6-2928-C954C785C6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78D36-185C-4E3A-8316-15111C1282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12645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B8B289-E4EF-B145-32FD-6F3607486E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C0D1C6-425A-25B7-948A-7BE1690A08E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3E3FE05-D56E-13E9-A566-AA085964EC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BEDAB11-6DAB-BB73-444F-138AC60FC9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85C8C-C0B2-4E24-8146-7579DAA60EFE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DD5A960-3EC0-4D9E-D04D-95B5A42CF2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7FD4EB-33FD-EF24-606C-41AE228623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78D36-185C-4E3A-8316-15111C1282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6740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FEC0CB-B740-A6B4-6B83-BA549440DE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076828-89EF-9890-072E-E6D2CD2030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C292073-C2C5-DA86-6488-A62C9D1E51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FC3631E-C45A-666F-F4A1-25CB65B7449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9DDB717-FE97-B7B3-53F5-0BD5906E616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7AD9738-3D7E-62EB-F7B3-3756F2F665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85C8C-C0B2-4E24-8146-7579DAA60EFE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CEE4A67-9B29-3D40-D000-866641687D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3F94E28-F8E3-29E8-EA61-9AAB45DE00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78D36-185C-4E3A-8316-15111C1282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28310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489988-BE80-4E07-07AC-CE350A20AB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1F81E3A-C3CA-D02A-CE13-64B7EFCDCC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85C8C-C0B2-4E24-8146-7579DAA60EFE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BA05CE6-441C-3F65-87AC-CB2069D00A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5B1A2C5-FB68-2357-B578-167FC897F2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78D36-185C-4E3A-8316-15111C1282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59281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C045FDE-B09A-99B3-D0C2-C97959604A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85C8C-C0B2-4E24-8146-7579DAA60EFE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7771528-DDA1-BBCF-A507-55856CE363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5F44DD3-FADD-39B9-F6CF-A9782235BC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78D36-185C-4E3A-8316-15111C1282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24465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F3E744-D989-BD72-B7BF-D958800D07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FA532A-8355-04E8-AA8D-D60F31B924C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DFE87A0-1034-D871-44C8-ED49FE5E82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48AD6C-05B0-D304-3962-66D4A5EB55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85C8C-C0B2-4E24-8146-7579DAA60EFE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88BDA0A-7715-EC39-EF2A-C4C9E238A9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C37AFF-3553-C182-9CF3-671631989D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78D36-185C-4E3A-8316-15111C1282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80736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63F913-E8CA-76A5-003E-FD9B3CAB9E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F63F965-0778-FA73-3473-964F346D3D4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3C7CCE8-7C7C-5DCE-DFDD-26D75515BA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AC5612-B0D0-943D-F563-041838717E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85C8C-C0B2-4E24-8146-7579DAA60EFE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636875-4C84-AFB3-1E1E-F0F2CED19C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407E06-83B3-0C50-AA30-2310D8E800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78D36-185C-4E3A-8316-15111C1282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18665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ECC5FDE-E573-8682-2CF9-546E648261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E0253B4-6EB9-1425-84F3-0A30D79F1C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79652C-5BAD-A104-B74F-7322950BBC9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6985C8C-C0B2-4E24-8146-7579DAA60EFE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A34B39-EEB6-EEAA-8C84-C081640E68C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00D553-AD3C-2EE2-F27D-B8BA4232DA1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5A78D36-185C-4E3A-8316-15111C1282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4358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D93728C-1370-B723-381F-DEAFC3D56B5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76075" y="1794189"/>
            <a:ext cx="6217103" cy="2133743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95BCFCE-9CF5-1E48-C350-B943F9BC8C0A}"/>
              </a:ext>
            </a:extLst>
          </p:cNvPr>
          <p:cNvSpPr txBox="1"/>
          <p:nvPr/>
        </p:nvSpPr>
        <p:spPr>
          <a:xfrm>
            <a:off x="2576075" y="4004634"/>
            <a:ext cx="6217103" cy="62773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fontAlgn="base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1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Supplemental Table 1. 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Numbers of images and cells captured per image by either manual or Cellpose segmentation. PDCOs from patients 1, 2, 3, and 5 are derived from metastatic rectal cancer and the remaining PDCOs are derived from local rectal cancer. All organoid data was acquired from Kratz et al.</a:t>
            </a:r>
            <a:r>
              <a:rPr lang="en-US" sz="1100" kern="1200" baseline="300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27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+mn-ea"/>
                <a:cs typeface="+mn-cs"/>
              </a:rPr>
              <a:t>.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136507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9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iendeau, Jeremiah</dc:creator>
  <cp:lastModifiedBy>Riendeau, Jeremiah</cp:lastModifiedBy>
  <cp:revision>2</cp:revision>
  <dcterms:created xsi:type="dcterms:W3CDTF">2024-06-07T20:40:43Z</dcterms:created>
  <dcterms:modified xsi:type="dcterms:W3CDTF">2024-06-07T20:44:54Z</dcterms:modified>
</cp:coreProperties>
</file>